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56" r:id="rId3"/>
    <p:sldId id="258" r:id="rId4"/>
    <p:sldId id="257" r:id="rId5"/>
    <p:sldId id="262" r:id="rId6"/>
    <p:sldId id="259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0D8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566"/>
    <p:restoredTop sz="96405"/>
  </p:normalViewPr>
  <p:slideViewPr>
    <p:cSldViewPr snapToGrid="0" snapToObjects="1">
      <p:cViewPr>
        <p:scale>
          <a:sx n="89" d="100"/>
          <a:sy n="89" d="100"/>
        </p:scale>
        <p:origin x="2256" y="1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28177-97C6-CF4E-8A90-7B24174907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CDF45D-6190-5D40-883C-53C80DC58F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A92BAE-75FC-A148-B4AD-43EB60E03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2BEB00-7035-9746-BFED-579B05E87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B7391B-2F73-4249-8273-D2A85F4F1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615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7FC5E-4017-E344-80F5-B370451C22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A8E2BA-3700-434C-8E48-38C82E30D8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613BC4-BD17-8A47-902F-DC42D299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FEBE6D-93A5-F441-AA52-492B5FD58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D29746-1C74-4C4E-A932-55B0AB4F6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605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5E2E3E-0DC3-E14F-AC2E-7D69485944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CD51AF-B2C3-E640-8DB8-FEF801B754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3C78E7-87EE-D848-B7C6-179C93B97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B569BF-7273-0448-B7D2-43F90E4AD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AACF4F-40D9-E843-A5FA-FEEA96023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046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8C60DD-41B5-9B49-97FB-D2CFF910CC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0D14EA-09E6-4546-B788-35FEB1C289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1E4530-4193-C24A-84EC-668E79D53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0D7E8B-40E0-DF42-9562-AE7262F72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DD7E1F-A898-C34D-A6CA-58CB789EE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252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D8401-4816-1546-B22E-8C13A35F2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F3D979-CAAA-C04D-A081-FB62860AF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119A91-1B6B-DD45-B74A-BBC3A0C90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5AACC6-3944-0840-9BD1-F5333C5B8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06086-2FAA-4D4C-8D21-A2871A0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580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DEF54-D803-C243-A2B0-D7B54E599E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FB5929-BE8C-2D40-9350-8439AF0650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44EC5A-79BB-444F-A43A-F2A45A9A6E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928FBF-A5CD-3D4C-B2DB-EADCB6A8E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4811F3-C9F4-3144-811C-40A5DC509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C601E9-EBD7-744C-9073-EECE488DD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759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C32431-864C-A145-B8BD-E4A7880934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B000B4-3AD8-7E48-A716-47355F4BE1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F7C631-78C5-794C-98E4-DEE2D00055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1D01FA-2894-9D4A-BEA3-85FC9723A2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1D397D-CDD4-5242-B9F0-51E73FFBB8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4E96A8-9FAD-FA46-B214-3E687E657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3D41C0-E800-7442-9428-D5DCA61A6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229B1D-53F7-FE40-9662-BA1091AB6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577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C4EF2-9D41-334B-B774-953EFF41E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AF52EB-88E7-B341-906B-532AB4009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CEFE24-D803-5247-B9A0-D874C8528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686ED2-DD6B-DD4A-B2F7-1DB758B715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982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ABC6323-7BC8-BF4E-8B15-266A36E9A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F9CD66-77BF-514C-81CB-D7479355A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949721-4E19-3948-A80F-5EE4DE1E6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7724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956805-B756-C947-9B02-0FFE4E7AF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0B0F43-AA48-7342-8788-E6726AA010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8A98C0-9CD2-9046-96F7-57FF4CD27F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A30394-FA47-0B42-80B6-4C5A4AFCD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AAB344-4A05-0342-9655-C6D0FFCEF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CB03F2-5007-E44C-8B54-DBD32C37A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144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67EBFA-878A-BC4E-BB30-F35675A13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30A3F3-2C33-7E4A-A7CE-C62AE88511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7719E9-B7BA-394F-9599-EDE6015F18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223DAB-E54D-0943-A7B6-C3A61C7BA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FB29D4-2ED9-3348-BAB3-3C64CD2B6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8668F8-44F0-7A46-BE78-46D4978E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85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5A9EB0-F9EB-1E45-B23E-889AFBB4B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FF0C70-AFFB-DC4A-81C8-1779674EED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EBC517-5C64-AB4B-9E3B-B5D666A158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B863D-5C60-0C44-BCDE-1B3DE7BB19F5}" type="datetimeFigureOut">
              <a:rPr lang="en-US" smtClean="0"/>
              <a:t>6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AED740-D049-AF43-802D-884C6642AE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4012E4-2B6A-DC46-BD44-5CBB51724A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6B2FC-1C8D-F842-8C77-FCF45C8658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148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1123CAF-57A0-1547-B103-3A3BA1869917}"/>
              </a:ext>
            </a:extLst>
          </p:cNvPr>
          <p:cNvSpPr txBox="1"/>
          <p:nvPr/>
        </p:nvSpPr>
        <p:spPr>
          <a:xfrm>
            <a:off x="1163905" y="4553695"/>
            <a:ext cx="10341458" cy="18947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Growth curves of BY4741 carrying different Cas9 constructs in SC–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dium.</a:t>
            </a:r>
          </a:p>
          <a:p>
            <a:pPr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Y4741 strains were transformed with Cas9 expression constructs in pRS416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9-CEN-URA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pRS426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9-2µ-URA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ackbones, along with control empty vectors pRS416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-URA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pRS426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µ-URA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OD600 was monitored on a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ek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on microplate spectrophotometer. Curves were used to calculate the doubling times as shown in Fig. 2d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7FAFFD1-D825-3545-B1D3-7FC9914B2A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5862" y="860293"/>
            <a:ext cx="5200276" cy="3508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1125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4B0F762-0AD9-6840-A9B7-C26A725D135C}"/>
              </a:ext>
            </a:extLst>
          </p:cNvPr>
          <p:cNvSpPr txBox="1"/>
          <p:nvPr/>
        </p:nvSpPr>
        <p:spPr>
          <a:xfrm>
            <a:off x="1163905" y="4551290"/>
            <a:ext cx="10341458" cy="189955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upplementary Figure 2. Colony PCR strategy used to screen for designer deletions in the </a:t>
            </a:r>
            <a:r>
              <a:rPr lang="en-US" sz="1600" b="1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ox2</a:t>
            </a: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construct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The forward primer (P1) anneals to the upstream region outside of homology arm in the donor DNA. The reverse primer (P2) anneals to e.g. CTCF8 deletion site, but the last 4 </a:t>
            </a:r>
            <a:r>
              <a:rPr lang="en-US" sz="1600" dirty="0" err="1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nt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at the 3’ end were designed to be unable to anneal to the original wild-type construct. The same strategy was used in the screening for other CTCF deletions. All primers used in this study are listed in Supplementary Table 4</a:t>
            </a: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CA05C2B-AD1A-CD4F-A334-04C9C3FD27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6762" y="552210"/>
            <a:ext cx="5558475" cy="3816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44944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4B0F762-0AD9-6840-A9B7-C26A725D135C}"/>
              </a:ext>
            </a:extLst>
          </p:cNvPr>
          <p:cNvSpPr txBox="1"/>
          <p:nvPr/>
        </p:nvSpPr>
        <p:spPr>
          <a:xfrm>
            <a:off x="1082884" y="4288676"/>
            <a:ext cx="10341458" cy="1160895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upplementary Figure 3. Successful deletion of CTCF8 as confirmed by WGS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WGS read coverage from clones positive for CTCF8 deletion, as identified by PCR genotyping. Reads were mapped to the </a:t>
            </a:r>
            <a:r>
              <a:rPr lang="en-US" sz="1600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mSox2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assembly. The short designer deletion of only 35 bp can be visualized by zooming into that region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BD1C2D6-84EB-924C-868A-88C25D55D4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9547" b="46296"/>
          <a:stretch/>
        </p:blipFill>
        <p:spPr>
          <a:xfrm>
            <a:off x="1347063" y="3219556"/>
            <a:ext cx="3104478" cy="307777"/>
          </a:xfrm>
          <a:prstGeom prst="rect">
            <a:avLst/>
          </a:prstGeom>
          <a:ln w="19050">
            <a:noFill/>
          </a:ln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71A5B23-437E-E749-8575-35B53747980F}"/>
              </a:ext>
            </a:extLst>
          </p:cNvPr>
          <p:cNvCxnSpPr>
            <a:cxnSpLocks/>
          </p:cNvCxnSpPr>
          <p:nvPr/>
        </p:nvCxnSpPr>
        <p:spPr>
          <a:xfrm flipH="1">
            <a:off x="1347063" y="2931249"/>
            <a:ext cx="1456846" cy="243841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34C4FA2-A07F-164F-AB12-1E79DECC0814}"/>
              </a:ext>
            </a:extLst>
          </p:cNvPr>
          <p:cNvCxnSpPr>
            <a:cxnSpLocks/>
          </p:cNvCxnSpPr>
          <p:nvPr/>
        </p:nvCxnSpPr>
        <p:spPr>
          <a:xfrm>
            <a:off x="2803909" y="2931249"/>
            <a:ext cx="1647632" cy="243841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BB57E82-70D9-F14B-A665-7543DFE9FB7D}"/>
              </a:ext>
            </a:extLst>
          </p:cNvPr>
          <p:cNvCxnSpPr>
            <a:cxnSpLocks/>
          </p:cNvCxnSpPr>
          <p:nvPr/>
        </p:nvCxnSpPr>
        <p:spPr>
          <a:xfrm>
            <a:off x="2803909" y="2765821"/>
            <a:ext cx="0" cy="165428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003650C1-6B3D-8747-9E84-4B1BDF7E5EE8}"/>
              </a:ext>
            </a:extLst>
          </p:cNvPr>
          <p:cNvSpPr txBox="1"/>
          <p:nvPr/>
        </p:nvSpPr>
        <p:spPr>
          <a:xfrm>
            <a:off x="2406642" y="3540303"/>
            <a:ext cx="872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solidFill>
                  <a:srgbClr val="E90D8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CF8∆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EEF5830-9BB9-5149-8FA4-DB8C775235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1293" y="1358090"/>
            <a:ext cx="10649413" cy="1376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1198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7E657FA-DABE-B046-8D70-CB92DF58232D}"/>
              </a:ext>
            </a:extLst>
          </p:cNvPr>
          <p:cNvSpPr txBox="1"/>
          <p:nvPr/>
        </p:nvSpPr>
        <p:spPr>
          <a:xfrm>
            <a:off x="925271" y="4781469"/>
            <a:ext cx="10341458" cy="15302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upplementary Figure 4. Sequencing coverage of Cas9/gRNA.CTCF8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WGS read coverage of clones derived from CTCF8 deletion experiments. Reads were aligned to the Cas9/gRNA.CTCF8 plasmid. All samples show full coverage of the plasmids, indicating the CRISPR system was still active. The </a:t>
            </a:r>
            <a:r>
              <a:rPr lang="en-US" sz="1600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2µ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origin region has higher coverage due to cross mapping of reads from the endogenous yeast </a:t>
            </a:r>
            <a:r>
              <a:rPr lang="en-US" sz="1600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2µ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locus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5B010EF-0087-154F-BBB2-54A3E861E4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194" y="805960"/>
            <a:ext cx="11279029" cy="3749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333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520F555-570B-B64E-9BC4-2487DB79224E}"/>
              </a:ext>
            </a:extLst>
          </p:cNvPr>
          <p:cNvSpPr txBox="1"/>
          <p:nvPr/>
        </p:nvSpPr>
        <p:spPr>
          <a:xfrm>
            <a:off x="1082884" y="4104010"/>
            <a:ext cx="10341458" cy="153022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upplementary Figure 5. Successful deletion of CTCF13, CTCF17 and CTCF25 as confirmed by WGS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WGS read coverage from clones positive for all three deletions, as identified by PCR genotyping. Reads were mapped to the </a:t>
            </a:r>
            <a:r>
              <a:rPr lang="en-US" sz="1600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mSox2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assembly. The short deletions of CTCF17 (35bp) and CTCF25 (84bp) can be visualized by zooming into that region. CTCT25 contains two motifs in opposite direction, and both were deleted as designed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01D1DCD-FC80-0640-8DBB-430E69A25A55}"/>
              </a:ext>
            </a:extLst>
          </p:cNvPr>
          <p:cNvCxnSpPr>
            <a:cxnSpLocks/>
          </p:cNvCxnSpPr>
          <p:nvPr/>
        </p:nvCxnSpPr>
        <p:spPr>
          <a:xfrm flipH="1">
            <a:off x="4001428" y="2970637"/>
            <a:ext cx="1456846" cy="243841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8F904EF4-7244-E448-B6BA-B33AD57CF0EB}"/>
              </a:ext>
            </a:extLst>
          </p:cNvPr>
          <p:cNvCxnSpPr>
            <a:cxnSpLocks/>
          </p:cNvCxnSpPr>
          <p:nvPr/>
        </p:nvCxnSpPr>
        <p:spPr>
          <a:xfrm>
            <a:off x="5458274" y="2970637"/>
            <a:ext cx="1647632" cy="243841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C6CFEB6-C082-E24F-B541-220F128D398F}"/>
              </a:ext>
            </a:extLst>
          </p:cNvPr>
          <p:cNvCxnSpPr>
            <a:cxnSpLocks/>
          </p:cNvCxnSpPr>
          <p:nvPr/>
        </p:nvCxnSpPr>
        <p:spPr>
          <a:xfrm>
            <a:off x="5458274" y="2805209"/>
            <a:ext cx="0" cy="165428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A0B55758-FF4E-DB4E-AAC7-D19028C37C1F}"/>
              </a:ext>
            </a:extLst>
          </p:cNvPr>
          <p:cNvSpPr txBox="1"/>
          <p:nvPr/>
        </p:nvSpPr>
        <p:spPr>
          <a:xfrm>
            <a:off x="4972403" y="3539290"/>
            <a:ext cx="9717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solidFill>
                  <a:srgbClr val="E90D8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CF17∆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676D4AD-77E1-6E4F-A5A0-9C708A63D1F1}"/>
              </a:ext>
            </a:extLst>
          </p:cNvPr>
          <p:cNvCxnSpPr>
            <a:cxnSpLocks/>
          </p:cNvCxnSpPr>
          <p:nvPr/>
        </p:nvCxnSpPr>
        <p:spPr>
          <a:xfrm flipH="1">
            <a:off x="8920856" y="2970637"/>
            <a:ext cx="1456846" cy="243841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77E3BE7-A493-7D4D-BEAA-EB699EDBE5F7}"/>
              </a:ext>
            </a:extLst>
          </p:cNvPr>
          <p:cNvCxnSpPr>
            <a:cxnSpLocks/>
          </p:cNvCxnSpPr>
          <p:nvPr/>
        </p:nvCxnSpPr>
        <p:spPr>
          <a:xfrm>
            <a:off x="10377702" y="2970637"/>
            <a:ext cx="1647632" cy="243841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BE3B8EA-E39F-8644-BF2D-A9F0DAB3BC60}"/>
              </a:ext>
            </a:extLst>
          </p:cNvPr>
          <p:cNvCxnSpPr>
            <a:cxnSpLocks/>
          </p:cNvCxnSpPr>
          <p:nvPr/>
        </p:nvCxnSpPr>
        <p:spPr>
          <a:xfrm>
            <a:off x="10377702" y="2805209"/>
            <a:ext cx="0" cy="165428"/>
          </a:xfrm>
          <a:prstGeom prst="line">
            <a:avLst/>
          </a:prstGeom>
          <a:ln w="15875" cap="rnd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CF54D69-EAC1-D349-BFF1-CC8A60483EE5}"/>
              </a:ext>
            </a:extLst>
          </p:cNvPr>
          <p:cNvSpPr txBox="1"/>
          <p:nvPr/>
        </p:nvSpPr>
        <p:spPr>
          <a:xfrm>
            <a:off x="9930742" y="3539290"/>
            <a:ext cx="9717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solidFill>
                  <a:srgbClr val="E90D8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CF25∆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68E1780-98BF-DC40-91BD-F375A43588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274" r="19458"/>
          <a:stretch/>
        </p:blipFill>
        <p:spPr>
          <a:xfrm>
            <a:off x="4001428" y="3181011"/>
            <a:ext cx="3104478" cy="34786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2B688BE-AE90-9648-B5F8-5BC10334516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003" r="19988"/>
          <a:stretch/>
        </p:blipFill>
        <p:spPr>
          <a:xfrm>
            <a:off x="8920856" y="3178483"/>
            <a:ext cx="3104478" cy="34786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337C54D-6561-1445-8DD5-676335A5DE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747" y="1782886"/>
            <a:ext cx="11016371" cy="1015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81176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7E657FA-DABE-B046-8D70-CB92DF58232D}"/>
              </a:ext>
            </a:extLst>
          </p:cNvPr>
          <p:cNvSpPr txBox="1"/>
          <p:nvPr/>
        </p:nvSpPr>
        <p:spPr>
          <a:xfrm>
            <a:off x="564855" y="4854622"/>
            <a:ext cx="11062290" cy="1160895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upplementary Figure 6. Sequencing coverage of Cas9/tRNA-gRNA array plasmid for multiplex editing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WGS read coverage of 14 samples from multiplex editing experiments were aligned to the Cas9 plasmid with a tRNA-gRNA array targeting at CTCF13, CTCF17 and CTCF25. In all but the “zero edits” group, the CRISPR plasmid remained intact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0E1DCFE-1C5D-B846-BB96-59EB337867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7128" y="1142999"/>
            <a:ext cx="10644675" cy="3488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846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F664C17-4814-C842-8BFC-685D3DA8F501}"/>
              </a:ext>
            </a:extLst>
          </p:cNvPr>
          <p:cNvSpPr txBox="1"/>
          <p:nvPr/>
        </p:nvSpPr>
        <p:spPr>
          <a:xfrm>
            <a:off x="564855" y="4485291"/>
            <a:ext cx="11062290" cy="189955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Supplementary Figure 7. Other CRISPR plasmids used to build additional </a:t>
            </a:r>
            <a:r>
              <a:rPr lang="en-US" sz="1600" b="1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mSox2</a:t>
            </a: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variants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Design of the pYTK-Cas9 system, containing both Cas9 and gRNA expression module, as a single-plasmid system. The Cas9 was codon-optimized for yeast, driven by a strong constitutive </a:t>
            </a:r>
            <a:r>
              <a:rPr lang="en-US" sz="1600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PGK1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promoter. The same tRNA-gRNA expression module was used in CREEPY for multiplex editing. </a:t>
            </a:r>
            <a:r>
              <a:rPr lang="en-US" sz="1600" b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The design of pNA0519 with human codon-optimized Cas9 driven by </a:t>
            </a:r>
            <a:r>
              <a:rPr lang="en-US" sz="1600" i="1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TEF1</a:t>
            </a:r>
            <a:r>
              <a:rPr lang="en-US" sz="1600" dirty="0">
                <a:solidFill>
                  <a:srgbClr val="000000"/>
                </a:solidFill>
                <a:latin typeface="TimesNewRomanPSMT"/>
                <a:ea typeface="DengXian" panose="02010600030101010101" pitchFamily="2" charset="-122"/>
                <a:cs typeface="Arial" panose="020B0604020202020204" pitchFamily="34" charset="0"/>
              </a:rPr>
              <a:t> promoter. The same Cas9 expression unit was used in CREEPY for both simplex and multiplex editing.</a:t>
            </a:r>
            <a:endParaRPr lang="en-US" sz="16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20A1646-DFB1-2746-9D06-904F56FDEB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294" y="732212"/>
            <a:ext cx="10071523" cy="3755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2560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7</TotalTime>
  <Words>546</Words>
  <Application>Microsoft Macintosh PowerPoint</Application>
  <PresentationFormat>Widescreen</PresentationFormat>
  <Paragraphs>1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TimesNewRomanPSMT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 Zhao</dc:creator>
  <cp:lastModifiedBy>Yu Zhao</cp:lastModifiedBy>
  <cp:revision>47</cp:revision>
  <dcterms:created xsi:type="dcterms:W3CDTF">2022-06-15T03:45:58Z</dcterms:created>
  <dcterms:modified xsi:type="dcterms:W3CDTF">2022-06-21T22:00:34Z</dcterms:modified>
</cp:coreProperties>
</file>